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BCDB5D50-636C-4540-8AA4-C67214451632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5CA0B7B9-175F-4950-B6DC-95D1398779A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87371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Google Shape;124;g34fe5d1bc1b_0_6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5" name="Google Shape;125;g34fe5d1bc1b_0_6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836D47-7208-44E7-9616-D6FB25E1EF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B01BB2A-6A95-42A0-A483-D602321AD2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472489-06D6-42BD-BBE1-E8C9B266BD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F2198-93B9-408B-8CA6-E8425C503A0F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76C24D-8FB1-4241-87F2-37AB52B061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22408C-01E9-4B5B-9301-A40B4FBA3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F1C14-4F84-4C5C-8067-B559F12EDA7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26942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B2F52-E8DC-4DA7-94FF-9E43D001E8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4FE5FC-1A2C-4A9E-A5C0-501820FF28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5A6FAE-D465-490B-9014-3AC3DB3BDA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F2198-93B9-408B-8CA6-E8425C503A0F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82413A-71D5-496E-9B2D-3EC3AF8B85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E036CB-7219-45C1-A105-100B4309C2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F1C14-4F84-4C5C-8067-B559F12EDA7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61383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68A6C9D-1838-44B3-91E5-D4AE809E5A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11EAF8-F132-4904-8DA1-7FB5330E0B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775F5B-EC3A-4AC1-961E-5ED0C33A8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F2198-93B9-408B-8CA6-E8425C503A0F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3F725C-B716-447C-B349-A26378E29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577B38-345F-4C10-9CA3-6CFC39DE6B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F1C14-4F84-4C5C-8067-B559F12EDA7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4574388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609585" lvl="0" indent="-457189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1219170" lvl="1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828754" lvl="2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2438339" lvl="3" indent="-423323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3047924" lvl="4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3657509" lvl="5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4267093" lvl="6" indent="-423323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4876678" lvl="7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5486263" lvl="8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algn="r"/>
            <a:fld id="{00000000-1234-1234-1234-123412341234}" type="slidenum">
              <a:rPr lang="en" smtClean="0"/>
              <a:pPr algn="r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2659807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79D25A-05DE-41FF-AD04-7AF82A1337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371A9E-AECC-4161-AC8A-DE784C56EC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DDFF1B-07B2-420C-B83F-3337C05A34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F2198-93B9-408B-8CA6-E8425C503A0F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E15D66-056A-469A-812F-376F558A4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A6392D-786F-4173-B431-DF1BA1074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F1C14-4F84-4C5C-8067-B559F12EDA7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49578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412DF8-D7D6-49DD-A2D3-9B00DF03DC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9C784D-5F18-4B72-9472-7E4C0AACF9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A1B000-D037-40D4-AA75-A9C07201C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F2198-93B9-408B-8CA6-E8425C503A0F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75CB16-5391-4564-B441-BF03080F7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AFDE91-6BDA-4854-916A-4D940574B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F1C14-4F84-4C5C-8067-B559F12EDA7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7915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85B21E-07F8-4EF3-9FBF-8F0AA4DF00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2FD746-E699-44EA-97FC-3CF19C274B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BE8BB0-58B6-48B9-B0D8-2DF028BC0E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D18119-05C0-4BE8-9419-C5F92AA0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F2198-93B9-408B-8CA6-E8425C503A0F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6F4C8A-D89F-4752-908D-62164BD50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A182A1-1BCF-4D1E-9C8F-4112FADF28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F1C14-4F84-4C5C-8067-B559F12EDA7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82255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9FDFFA-7B59-4939-B837-0688099BE3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793ABF-5D2B-4918-A365-E095C5DC52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9C1B5D-B14D-4FB6-A1E5-7D1A153BB2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06EDB4-DD14-4A48-A2B8-61BD0E410B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AC447A0-8326-4E3D-8D96-F15E325D7C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9AF45AC-6210-403E-959C-5D351E4AC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F2198-93B9-408B-8CA6-E8425C503A0F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1A6D307-1EDF-4B77-9C56-7E8436AA66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1AFC58-6129-4C90-A4C0-A5063ADE1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F1C14-4F84-4C5C-8067-B559F12EDA7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36010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AE7939-6BF0-4F48-8AB9-3CD00621C0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95FA246-19CD-4761-B89F-EB1D8BBDA7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F2198-93B9-408B-8CA6-E8425C503A0F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A22328-87FE-4353-98E1-0D376EA78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F40A5A-6541-433E-889D-A508194A8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F1C14-4F84-4C5C-8067-B559F12EDA7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11908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6549281-6B7F-4C74-B8E3-64D2E52A0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F2198-93B9-408B-8CA6-E8425C503A0F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3B7674-C617-4D1C-B90A-1C73443D3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9C5D5E-0D6E-4124-BB66-D14D4A6DA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F1C14-4F84-4C5C-8067-B559F12EDA7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52327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83CCA7-0AC4-4AD2-BB0A-64E435066E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15485A-4169-403E-AB9C-700B3A07E8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7889CA-7494-49B4-AF05-5DC0B4B3D5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FB9DBD-4F9F-40F6-8DF5-0AC15325C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F2198-93B9-408B-8CA6-E8425C503A0F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2FA63C-48A1-481A-8B61-1D695326F5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946199-180F-467E-8202-B80869085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F1C14-4F84-4C5C-8067-B559F12EDA7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95238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E1DAA7-E64C-432E-BB53-6A7B338550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6F5762-97DA-4F8C-A464-04F2ACE1BE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1D6DC3-A242-45CC-AB5D-55D5BE19F9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88FFC7-DDAD-4870-B408-B41081EA5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F2198-93B9-408B-8CA6-E8425C503A0F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37A365-A9F0-4202-9BF3-354583272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95B3E7-0275-49E5-87E2-CD151E7C8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F1C14-4F84-4C5C-8067-B559F12EDA7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32950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4335442-940E-43B2-A6D3-542F8AED06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9F6329-1932-4861-9B06-4EC34DE726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98DCBF-B0E6-4635-8EEB-9FCF118D5E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4F2198-93B9-408B-8CA6-E8425C503A0F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107334-DB66-42EE-832B-C80F2557D8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E26FD4-C91D-46F5-8B15-8237B0473A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9F1C14-4F84-4C5C-8067-B559F12EDA7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76224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8E374B8D-FCE9-4A4C-A181-DDDE3ADEF3D4}"/>
              </a:ext>
            </a:extLst>
          </p:cNvPr>
          <p:cNvGrpSpPr/>
          <p:nvPr/>
        </p:nvGrpSpPr>
        <p:grpSpPr>
          <a:xfrm>
            <a:off x="330906" y="721502"/>
            <a:ext cx="10784299" cy="5276033"/>
            <a:chOff x="3666134" y="182801"/>
            <a:chExt cx="10784299" cy="5276033"/>
          </a:xfrm>
        </p:grpSpPr>
        <p:pic>
          <p:nvPicPr>
            <p:cNvPr id="127" name="Google Shape;127;p19"/>
            <p:cNvPicPr preferRelativeResize="0"/>
            <p:nvPr/>
          </p:nvPicPr>
          <p:blipFill>
            <a:blip r:embed="rId3">
              <a:alphaModFix/>
            </a:blip>
            <a:stretch>
              <a:fillRect/>
            </a:stretch>
          </p:blipFill>
          <p:spPr>
            <a:xfrm>
              <a:off x="3666134" y="182801"/>
              <a:ext cx="10784299" cy="527603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9" name="Google Shape;129;p19"/>
            <p:cNvSpPr txBox="1"/>
            <p:nvPr/>
          </p:nvSpPr>
          <p:spPr>
            <a:xfrm>
              <a:off x="5034982" y="497706"/>
              <a:ext cx="531600" cy="61551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2400" dirty="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a</a:t>
              </a:r>
              <a:endParaRPr sz="24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130" name="Google Shape;130;p19"/>
            <p:cNvSpPr txBox="1"/>
            <p:nvPr/>
          </p:nvSpPr>
          <p:spPr>
            <a:xfrm>
              <a:off x="8230141" y="571176"/>
              <a:ext cx="531600" cy="61551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2400" dirty="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b</a:t>
              </a:r>
              <a:endParaRPr sz="24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131" name="Google Shape;131;p19"/>
            <p:cNvSpPr txBox="1"/>
            <p:nvPr/>
          </p:nvSpPr>
          <p:spPr>
            <a:xfrm>
              <a:off x="11340287" y="519829"/>
              <a:ext cx="531600" cy="61551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2400" dirty="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c</a:t>
              </a:r>
              <a:endParaRPr sz="24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132" name="Google Shape;132;p19"/>
            <p:cNvSpPr txBox="1"/>
            <p:nvPr/>
          </p:nvSpPr>
          <p:spPr>
            <a:xfrm>
              <a:off x="7617969" y="3049164"/>
              <a:ext cx="531600" cy="61551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2400" dirty="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d</a:t>
              </a:r>
              <a:endParaRPr sz="24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133" name="Google Shape;133;p19"/>
            <p:cNvSpPr txBox="1"/>
            <p:nvPr/>
          </p:nvSpPr>
          <p:spPr>
            <a:xfrm>
              <a:off x="8264633" y="2980168"/>
              <a:ext cx="531600" cy="61551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2400" dirty="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e</a:t>
              </a:r>
              <a:endParaRPr sz="24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134" name="Google Shape;134;p19"/>
            <p:cNvSpPr txBox="1"/>
            <p:nvPr/>
          </p:nvSpPr>
          <p:spPr>
            <a:xfrm>
              <a:off x="11455833" y="2980167"/>
              <a:ext cx="531600" cy="61551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2400" dirty="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f</a:t>
              </a:r>
              <a:endParaRPr sz="24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79233F0A-6865-456C-8E7B-6F66079E1F6A}"/>
              </a:ext>
            </a:extLst>
          </p:cNvPr>
          <p:cNvSpPr/>
          <p:nvPr/>
        </p:nvSpPr>
        <p:spPr>
          <a:xfrm>
            <a:off x="600721" y="6081607"/>
            <a:ext cx="1024466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verse sections of stem and storage roots indicating GUS localization, particularly in phloem tissues. </a:t>
            </a: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Histochemical localization of</a:t>
            </a:r>
            <a:r>
              <a:rPr lang="en-US" sz="1200" b="1" dirty="0">
                <a:solidFill>
                  <a:schemeClr val="dk1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 </a:t>
            </a: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SUC2: GUS expression in transgenic plants and non-transgenic (WT) of cassava cv. 60444. In vitro leaves (a, d), cross sections of stems (b, e) and storage roots (c, f) from12-week old plants grown in the greenhouse.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0668726-2FB4-F6AB-6165-11762607A5B5}"/>
              </a:ext>
            </a:extLst>
          </p:cNvPr>
          <p:cNvSpPr/>
          <p:nvPr/>
        </p:nvSpPr>
        <p:spPr>
          <a:xfrm>
            <a:off x="640080" y="1805940"/>
            <a:ext cx="960120" cy="3314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79</Words>
  <Application>Microsoft Office PowerPoint</Application>
  <PresentationFormat>Widescreen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snat Malka</dc:creator>
  <cp:lastModifiedBy>Shai Morin</cp:lastModifiedBy>
  <cp:revision>5</cp:revision>
  <dcterms:created xsi:type="dcterms:W3CDTF">2026-01-21T11:10:55Z</dcterms:created>
  <dcterms:modified xsi:type="dcterms:W3CDTF">2026-02-16T08:17:01Z</dcterms:modified>
</cp:coreProperties>
</file>